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9" r:id="rId3"/>
    <p:sldId id="267" r:id="rId4"/>
  </p:sldIdLst>
  <p:sldSz cx="6858000" cy="9144000" type="screen4x3"/>
  <p:notesSz cx="67945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500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4" d="100"/>
          <a:sy n="54" d="100"/>
        </p:scale>
        <p:origin x="2024" y="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3978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213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865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6403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2213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170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511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378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807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8839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017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9720E9-172A-415E-9863-C4EB3AD5F6DD}" type="datetimeFigureOut">
              <a:rPr lang="en-GB" smtClean="0"/>
              <a:t>12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FEDD8D-B992-46B6-BA49-9DA08BD94B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030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27" y="5230192"/>
            <a:ext cx="2412450" cy="225800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900" y="729846"/>
            <a:ext cx="4476890" cy="3100749"/>
          </a:xfrm>
          <a:prstGeom prst="rect">
            <a:avLst/>
          </a:prstGeom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710450">
            <a:off x="1787076" y="4567349"/>
            <a:ext cx="4917644" cy="40329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59489" y="123564"/>
            <a:ext cx="5255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152768" y="926757"/>
            <a:ext cx="154459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Location of the GM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elina trial on the Rothamsted Experimental Farm. The fenced trial area is shown in brown; the trial plot in blue.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9489" y="7797114"/>
            <a:ext cx="18905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e precise location of the trial site.  The inner blue box is the area containing GM Camelina, in the plot layout shown in (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00400" y="8711514"/>
            <a:ext cx="16683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GM plot layout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37624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6521" y="1017270"/>
            <a:ext cx="4112227" cy="6664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817370" y="1223010"/>
            <a:ext cx="898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) EP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17370" y="457581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) DH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59386" y="7938424"/>
            <a:ext cx="5255670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Box plots of single seed EPA &amp; DHA fatty acid distribution.</a:t>
            </a:r>
          </a:p>
          <a:p>
            <a:r>
              <a:rPr lang="en-GB" sz="1600" dirty="0" smtClean="0"/>
              <a:t>GM trail = pooled samples from GM-E and GM-W plots.</a:t>
            </a:r>
          </a:p>
          <a:p>
            <a:r>
              <a:rPr lang="en-GB" sz="1600" dirty="0" smtClean="0"/>
              <a:t>Glasshouse = identical line grown under controlled conditions</a:t>
            </a:r>
          </a:p>
          <a:p>
            <a:endParaRPr lang="en-GB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259489" y="222420"/>
            <a:ext cx="5255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4548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8845" y="978957"/>
            <a:ext cx="3761558" cy="279221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9489" y="222420"/>
            <a:ext cx="5255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714500" y="4336106"/>
            <a:ext cx="3429000" cy="144655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dirty="0"/>
              <a:t>	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	SE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T GH	6.009	0.34745632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M GH	10.191	0.990811432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WT field	6.820	0.054244343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M West	8.085	0.026722249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GM East	8.166	0.023330532</a:t>
            </a:r>
          </a:p>
        </p:txBody>
      </p:sp>
    </p:spTree>
    <p:extLst>
      <p:ext uri="{BB962C8B-B14F-4D97-AF65-F5344CB8AC3E}">
        <p14:creationId xmlns:p14="http://schemas.microsoft.com/office/powerpoint/2010/main" val="393209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50</TotalTime>
  <Words>113</Words>
  <Application>Microsoft Office PowerPoint</Application>
  <PresentationFormat>On-screen Show (4:3)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Rothamste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Haslam</dc:creator>
  <cp:lastModifiedBy>Jackie Barker</cp:lastModifiedBy>
  <cp:revision>30</cp:revision>
  <cp:lastPrinted>2014-11-03T15:30:26Z</cp:lastPrinted>
  <dcterms:created xsi:type="dcterms:W3CDTF">2014-10-20T13:43:27Z</dcterms:created>
  <dcterms:modified xsi:type="dcterms:W3CDTF">2015-04-12T19:29:09Z</dcterms:modified>
</cp:coreProperties>
</file>